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6" r:id="rId11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6" d="100"/>
          <a:sy n="96" d="100"/>
        </p:scale>
        <p:origin x="-1066" y="-91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9456E-A8E0-4C00-979D-53D39207E4BE}" type="datetimeFigureOut">
              <a:rPr lang="en-CA" smtClean="0"/>
              <a:t>2018-06-1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4BA9B-58EC-4793-85F1-C1CCF64B401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116556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9456E-A8E0-4C00-979D-53D39207E4BE}" type="datetimeFigureOut">
              <a:rPr lang="en-CA" smtClean="0"/>
              <a:t>2018-06-1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4BA9B-58EC-4793-85F1-C1CCF64B401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537907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9456E-A8E0-4C00-979D-53D39207E4BE}" type="datetimeFigureOut">
              <a:rPr lang="en-CA" smtClean="0"/>
              <a:t>2018-06-1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4BA9B-58EC-4793-85F1-C1CCF64B401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314734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9456E-A8E0-4C00-979D-53D39207E4BE}" type="datetimeFigureOut">
              <a:rPr lang="en-CA" smtClean="0"/>
              <a:t>2018-06-1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4BA9B-58EC-4793-85F1-C1CCF64B401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512059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9456E-A8E0-4C00-979D-53D39207E4BE}" type="datetimeFigureOut">
              <a:rPr lang="en-CA" smtClean="0"/>
              <a:t>2018-06-1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4BA9B-58EC-4793-85F1-C1CCF64B401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287876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9456E-A8E0-4C00-979D-53D39207E4BE}" type="datetimeFigureOut">
              <a:rPr lang="en-CA" smtClean="0"/>
              <a:t>2018-06-18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4BA9B-58EC-4793-85F1-C1CCF64B401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354065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9456E-A8E0-4C00-979D-53D39207E4BE}" type="datetimeFigureOut">
              <a:rPr lang="en-CA" smtClean="0"/>
              <a:t>2018-06-18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4BA9B-58EC-4793-85F1-C1CCF64B401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97143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9456E-A8E0-4C00-979D-53D39207E4BE}" type="datetimeFigureOut">
              <a:rPr lang="en-CA" smtClean="0"/>
              <a:t>2018-06-18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4BA9B-58EC-4793-85F1-C1CCF64B401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967729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9456E-A8E0-4C00-979D-53D39207E4BE}" type="datetimeFigureOut">
              <a:rPr lang="en-CA" smtClean="0"/>
              <a:t>2018-06-18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4BA9B-58EC-4793-85F1-C1CCF64B401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963469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9456E-A8E0-4C00-979D-53D39207E4BE}" type="datetimeFigureOut">
              <a:rPr lang="en-CA" smtClean="0"/>
              <a:t>2018-06-18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4BA9B-58EC-4793-85F1-C1CCF64B401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0863075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9456E-A8E0-4C00-979D-53D39207E4BE}" type="datetimeFigureOut">
              <a:rPr lang="en-CA" smtClean="0"/>
              <a:t>2018-06-18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4BA9B-58EC-4793-85F1-C1CCF64B401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535300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39456E-A8E0-4C00-979D-53D39207E4BE}" type="datetimeFigureOut">
              <a:rPr lang="en-CA" smtClean="0"/>
              <a:t>2018-06-1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D4BA9B-58EC-4793-85F1-C1CCF64B401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766547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83568" y="1901496"/>
            <a:ext cx="8061566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 smtClean="0"/>
              <a:t>Supplementary Figure 2. </a:t>
            </a:r>
            <a:r>
              <a:rPr lang="en-CA" dirty="0"/>
              <a:t>Gene </a:t>
            </a:r>
            <a:r>
              <a:rPr lang="en-CA" dirty="0" smtClean="0"/>
              <a:t>expression patterns </a:t>
            </a:r>
            <a:r>
              <a:rPr lang="en-CA" dirty="0"/>
              <a:t>in </a:t>
            </a:r>
            <a:r>
              <a:rPr lang="en-CA" i="1" dirty="0"/>
              <a:t>C. </a:t>
            </a:r>
            <a:r>
              <a:rPr lang="en-CA" i="1" dirty="0" err="1"/>
              <a:t>sativa</a:t>
            </a:r>
            <a:r>
              <a:rPr lang="en-CA" i="1" dirty="0"/>
              <a:t> </a:t>
            </a:r>
            <a:r>
              <a:rPr lang="en-CA" dirty="0"/>
              <a:t>lines expressing </a:t>
            </a:r>
            <a:r>
              <a:rPr lang="en-CA" i="1" dirty="0" err="1"/>
              <a:t>acdS</a:t>
            </a:r>
            <a:r>
              <a:rPr lang="en-CA" dirty="0"/>
              <a:t> </a:t>
            </a:r>
            <a:endParaRPr lang="en-CA" dirty="0" smtClean="0"/>
          </a:p>
          <a:p>
            <a:r>
              <a:rPr lang="en-CA" dirty="0" smtClean="0"/>
              <a:t>under </a:t>
            </a:r>
            <a:r>
              <a:rPr lang="en-CA" dirty="0"/>
              <a:t>the control of the root-specific </a:t>
            </a:r>
            <a:r>
              <a:rPr lang="en-CA" i="1" dirty="0" err="1"/>
              <a:t>rolD</a:t>
            </a:r>
            <a:r>
              <a:rPr lang="en-CA" dirty="0"/>
              <a:t> promoter or the constitutive </a:t>
            </a:r>
            <a:r>
              <a:rPr lang="en-CA" dirty="0" err="1"/>
              <a:t>CaMV</a:t>
            </a:r>
            <a:r>
              <a:rPr lang="en-CA" dirty="0"/>
              <a:t> </a:t>
            </a:r>
            <a:r>
              <a:rPr lang="en-CA" i="1" dirty="0"/>
              <a:t>35S</a:t>
            </a:r>
            <a:r>
              <a:rPr lang="en-CA" dirty="0"/>
              <a:t> </a:t>
            </a:r>
            <a:endParaRPr lang="en-CA" dirty="0" smtClean="0"/>
          </a:p>
          <a:p>
            <a:r>
              <a:rPr lang="en-CA" dirty="0" smtClean="0"/>
              <a:t>promoter </a:t>
            </a:r>
            <a:r>
              <a:rPr lang="en-CA" dirty="0"/>
              <a:t>or treated with </a:t>
            </a:r>
            <a:r>
              <a:rPr lang="en-CA" i="1" dirty="0"/>
              <a:t>P. </a:t>
            </a:r>
            <a:r>
              <a:rPr lang="en-CA" i="1" dirty="0" err="1"/>
              <a:t>migulae</a:t>
            </a:r>
            <a:r>
              <a:rPr lang="en-CA" dirty="0"/>
              <a:t> </a:t>
            </a:r>
            <a:r>
              <a:rPr lang="en-CA" dirty="0" smtClean="0"/>
              <a:t>8R6 </a:t>
            </a:r>
            <a:r>
              <a:rPr lang="en-CA" dirty="0"/>
              <a:t>in the presence of </a:t>
            </a:r>
            <a:r>
              <a:rPr lang="en-CA" dirty="0" smtClean="0"/>
              <a:t>salt.  Heat </a:t>
            </a:r>
            <a:r>
              <a:rPr lang="en-CA" dirty="0"/>
              <a:t>maps </a:t>
            </a:r>
            <a:r>
              <a:rPr lang="en-CA" dirty="0" smtClean="0"/>
              <a:t>are </a:t>
            </a:r>
          </a:p>
          <a:p>
            <a:r>
              <a:rPr lang="en-CA" dirty="0" smtClean="0"/>
              <a:t>superimposed </a:t>
            </a:r>
            <a:r>
              <a:rPr lang="en-CA" dirty="0"/>
              <a:t>on </a:t>
            </a:r>
            <a:r>
              <a:rPr lang="en-CA" dirty="0" smtClean="0"/>
              <a:t>gene ontology descriptions as generated in MAPMAN.</a:t>
            </a:r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31837142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 descr="C:\Users\heydarianz\Desktop\camelina secound manscript and third data\third manscript\Map man third manscript\root\map man figurs\rold  rootmetabolisume.jp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7440"/>
          <a:stretch/>
        </p:blipFill>
        <p:spPr bwMode="auto">
          <a:xfrm>
            <a:off x="611560" y="260648"/>
            <a:ext cx="8355784" cy="62007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7452320" y="6303744"/>
            <a:ext cx="14401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err="1" smtClean="0"/>
              <a:t>rolD</a:t>
            </a:r>
            <a:r>
              <a:rPr lang="en-CA" dirty="0" smtClean="0"/>
              <a:t>::</a:t>
            </a:r>
            <a:r>
              <a:rPr lang="en-CA" dirty="0" err="1" smtClean="0"/>
              <a:t>acdS</a:t>
            </a:r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35587815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heydarianz\Desktop\camelina secound manscript and third data\third manscript\Map man third manscript\root\map man figurs\8r6 roo regulation.jp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1869"/>
          <a:stretch/>
        </p:blipFill>
        <p:spPr bwMode="auto">
          <a:xfrm>
            <a:off x="971600" y="764704"/>
            <a:ext cx="7144284" cy="506502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3131840" y="6093296"/>
            <a:ext cx="14119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/>
              <a:t>8R6-PGPB </a:t>
            </a:r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3068790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C:\Users\heydarianz\Desktop\camelina secound manscript and third data\third manscript\Map man third manscript\root\map man figurs\35S roo regulation.jp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1776"/>
          <a:stretch/>
        </p:blipFill>
        <p:spPr bwMode="auto">
          <a:xfrm>
            <a:off x="1115616" y="836712"/>
            <a:ext cx="7152830" cy="507289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3131840" y="6093296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/>
              <a:t>35S::</a:t>
            </a:r>
            <a:r>
              <a:rPr lang="en-CA" dirty="0" err="1" smtClean="0"/>
              <a:t>acdS</a:t>
            </a:r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42487601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C:\Users\heydarianz\Desktop\camelina secound manscript and third data\third manscript\Map man third manscript\root\map man figurs\rold roo regulation.jp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2056"/>
          <a:stretch/>
        </p:blipFill>
        <p:spPr bwMode="auto">
          <a:xfrm>
            <a:off x="827584" y="894521"/>
            <a:ext cx="7127193" cy="506895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3131840" y="6093296"/>
            <a:ext cx="14401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err="1" smtClean="0"/>
              <a:t>rolD</a:t>
            </a:r>
            <a:r>
              <a:rPr lang="en-CA" dirty="0" smtClean="0"/>
              <a:t>::</a:t>
            </a:r>
            <a:r>
              <a:rPr lang="en-CA" dirty="0" err="1" smtClean="0"/>
              <a:t>acdS</a:t>
            </a:r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21674484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C:\Users\heydarianz\Desktop\camelina secound manscript and third data\third manscript\Map man third manscript\root\map man figurs\8r6 root biotic stress.jp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8659"/>
          <a:stretch/>
        </p:blipFill>
        <p:spPr bwMode="auto">
          <a:xfrm>
            <a:off x="1259632" y="844528"/>
            <a:ext cx="6856354" cy="51435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3131840" y="6093296"/>
            <a:ext cx="14119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/>
              <a:t>8R6-PGPB </a:t>
            </a:r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278415583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 descr="C:\Users\heydarianz\Desktop\camelina secound manscript and third data\third manscript\Map man third manscript\root\map man figurs\35S root biotic stress.jp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8038"/>
          <a:stretch/>
        </p:blipFill>
        <p:spPr bwMode="auto">
          <a:xfrm>
            <a:off x="1403648" y="977282"/>
            <a:ext cx="6580262" cy="49034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3131840" y="6093296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/>
              <a:t>35S::</a:t>
            </a:r>
            <a:r>
              <a:rPr lang="en-CA" dirty="0" err="1" smtClean="0"/>
              <a:t>acdS</a:t>
            </a:r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311713831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 descr="C:\Users\heydarianz\Desktop\camelina secound manscript and third data\third manscript\Map man third manscript\root\map man figurs\rold  root biotic stress.jp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8282"/>
          <a:stretch/>
        </p:blipFill>
        <p:spPr bwMode="auto">
          <a:xfrm>
            <a:off x="1115616" y="867641"/>
            <a:ext cx="6885774" cy="51435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3131840" y="6093296"/>
            <a:ext cx="14401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err="1" smtClean="0"/>
              <a:t>rolD</a:t>
            </a:r>
            <a:r>
              <a:rPr lang="en-CA" dirty="0" smtClean="0"/>
              <a:t>::</a:t>
            </a:r>
            <a:r>
              <a:rPr lang="en-CA" dirty="0" err="1" smtClean="0"/>
              <a:t>acdS</a:t>
            </a:r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66060549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 descr="C:\Users\heydarianz\Desktop\camelina secound manscript and third data\third manscript\Map man third manscript\root\map man figurs\8r6 rootmetabolisume.jp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7755"/>
          <a:stretch/>
        </p:blipFill>
        <p:spPr bwMode="auto">
          <a:xfrm>
            <a:off x="683568" y="328613"/>
            <a:ext cx="8326363" cy="62007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7598175" y="6471721"/>
            <a:ext cx="14119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/>
              <a:t>8R6-PGPB </a:t>
            </a:r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103089614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 descr="C:\Users\heydarianz\Desktop\camelina secound manscript and third data\third manscript\Map man third manscript\root\map man figurs\35S rootmetabolisume.jp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7793"/>
          <a:stretch/>
        </p:blipFill>
        <p:spPr bwMode="auto">
          <a:xfrm>
            <a:off x="539552" y="188640"/>
            <a:ext cx="8308293" cy="62007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7884368" y="6389415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/>
              <a:t>35S::</a:t>
            </a:r>
            <a:r>
              <a:rPr lang="en-CA" dirty="0" err="1" smtClean="0"/>
              <a:t>acdS</a:t>
            </a:r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41876749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75</Words>
  <Application>Microsoft Office PowerPoint</Application>
  <PresentationFormat>On-screen Show (4:3)</PresentationFormat>
  <Paragraphs>13</Paragraphs>
  <Slides>10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1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AAFC-AA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ydarian, Zohreh</dc:creator>
  <cp:lastModifiedBy>Hegedus, Dwayne</cp:lastModifiedBy>
  <cp:revision>4</cp:revision>
  <dcterms:created xsi:type="dcterms:W3CDTF">2017-10-10T20:14:48Z</dcterms:created>
  <dcterms:modified xsi:type="dcterms:W3CDTF">2018-06-18T22:16:19Z</dcterms:modified>
</cp:coreProperties>
</file>